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6" r:id="rId2"/>
    <p:sldId id="300" r:id="rId3"/>
    <p:sldId id="302" r:id="rId4"/>
    <p:sldId id="297" r:id="rId5"/>
    <p:sldId id="303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2892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D:\!%20&#23455;&#39443;&#31561;\@%20PLASMA\@%20&#23450;&#26399;&#12511;&#12540;&#12486;&#12451;&#12531;&#12464;\2021-10-02\data\WB\LM8%20CC3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D:\!%20&#23455;&#39443;&#31561;\@%20PLASMA\@%20&#23450;&#26399;&#12511;&#12540;&#12486;&#12451;&#12531;&#12464;\2021-10-02\data\WB\143B%20CC3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D:\!%20&#23455;&#39443;&#31561;\@%20PLASMA\@%20&#23450;&#26399;&#12511;&#12540;&#12486;&#12451;&#12531;&#12464;\2021-10-02\data\WB\LM8%20LC3%20AB.csv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D:\!%20&#23455;&#39443;&#31561;\@%20PLASMA\@%20&#23450;&#26399;&#12511;&#12540;&#12486;&#12451;&#12531;&#12464;\2021-10-02\data\WB\143B%20LC3%20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LM8 CC3'!$B$10:$B$14</c:f>
              <c:strCache>
                <c:ptCount val="5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strCache>
            </c:strRef>
          </c:cat>
          <c:val>
            <c:numRef>
              <c:f>'LM8 CC3'!$C$10:$C$14</c:f>
              <c:numCache>
                <c:formatCode>General</c:formatCode>
                <c:ptCount val="5"/>
                <c:pt idx="0">
                  <c:v>7.6959694989106753</c:v>
                </c:pt>
                <c:pt idx="1">
                  <c:v>8.371132897603486</c:v>
                </c:pt>
                <c:pt idx="2">
                  <c:v>10.262200435729847</c:v>
                </c:pt>
                <c:pt idx="3">
                  <c:v>11.171023965141611</c:v>
                </c:pt>
                <c:pt idx="4">
                  <c:v>15.3969498910675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07-46DD-B197-6D8AA09D80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6014984"/>
        <c:axId val="516016296"/>
      </c:barChart>
      <c:catAx>
        <c:axId val="516014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016296"/>
        <c:crosses val="autoZero"/>
        <c:auto val="1"/>
        <c:lblAlgn val="ctr"/>
        <c:lblOffset val="100"/>
        <c:noMultiLvlLbl val="0"/>
      </c:catAx>
      <c:valAx>
        <c:axId val="516016296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014984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143B CC3'!$B$10:$B$14</c:f>
              <c:strCache>
                <c:ptCount val="5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strCache>
            </c:strRef>
          </c:cat>
          <c:val>
            <c:numRef>
              <c:f>'143B CC3'!$C$10:$C$14</c:f>
              <c:numCache>
                <c:formatCode>General</c:formatCode>
                <c:ptCount val="5"/>
                <c:pt idx="0">
                  <c:v>1.611328125</c:v>
                </c:pt>
                <c:pt idx="1">
                  <c:v>1.6176269531249998</c:v>
                </c:pt>
                <c:pt idx="2">
                  <c:v>1.6681640625</c:v>
                </c:pt>
                <c:pt idx="3">
                  <c:v>1.6466796874999998</c:v>
                </c:pt>
                <c:pt idx="4">
                  <c:v>1.64189453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F1-459E-AA50-2342E085DC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6014984"/>
        <c:axId val="516016296"/>
      </c:barChart>
      <c:catAx>
        <c:axId val="516014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016296"/>
        <c:crosses val="autoZero"/>
        <c:auto val="1"/>
        <c:lblAlgn val="ctr"/>
        <c:lblOffset val="100"/>
        <c:noMultiLvlLbl val="0"/>
      </c:catAx>
      <c:valAx>
        <c:axId val="516016296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014984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LM8 LC3 AB'!$B$11:$B$16</c:f>
              <c:strCache>
                <c:ptCount val="6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  <c:pt idx="5">
                  <c:v>48</c:v>
                </c:pt>
              </c:strCache>
            </c:strRef>
          </c:cat>
          <c:val>
            <c:numRef>
              <c:f>'LM8 LC3 AB'!$C$11:$C$16</c:f>
              <c:numCache>
                <c:formatCode>General</c:formatCode>
                <c:ptCount val="6"/>
                <c:pt idx="0">
                  <c:v>4.6534798534798538</c:v>
                </c:pt>
                <c:pt idx="1">
                  <c:v>4.6845543345543348</c:v>
                </c:pt>
                <c:pt idx="2">
                  <c:v>4.3211233211233218</c:v>
                </c:pt>
                <c:pt idx="3">
                  <c:v>4.2170940170940172</c:v>
                </c:pt>
                <c:pt idx="4">
                  <c:v>4.0226495726495735</c:v>
                </c:pt>
                <c:pt idx="5">
                  <c:v>8.9426129426129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620-47B9-8D64-5CC25EEDCC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6014984"/>
        <c:axId val="516016296"/>
      </c:barChart>
      <c:catAx>
        <c:axId val="516014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16016296"/>
        <c:crosses val="autoZero"/>
        <c:auto val="1"/>
        <c:lblAlgn val="ctr"/>
        <c:lblOffset val="100"/>
        <c:noMultiLvlLbl val="0"/>
      </c:catAx>
      <c:valAx>
        <c:axId val="516016296"/>
        <c:scaling>
          <c:orientation val="minMax"/>
          <c:max val="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16014984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LM8 LC3 AB'!$B$11:$B$16</c:f>
              <c:strCache>
                <c:ptCount val="6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  <c:pt idx="5">
                  <c:v>48</c:v>
                </c:pt>
              </c:strCache>
            </c:strRef>
          </c:cat>
          <c:val>
            <c:numRef>
              <c:f>'LM8 LC3 AB'!$C$11:$C$16</c:f>
              <c:numCache>
                <c:formatCode>General</c:formatCode>
                <c:ptCount val="6"/>
                <c:pt idx="0">
                  <c:v>3.8252234359483621</c:v>
                </c:pt>
                <c:pt idx="1">
                  <c:v>4.9828202581926515</c:v>
                </c:pt>
                <c:pt idx="2">
                  <c:v>5.060377358490566</c:v>
                </c:pt>
                <c:pt idx="3">
                  <c:v>6.2470705064548167</c:v>
                </c:pt>
                <c:pt idx="4">
                  <c:v>6.5699106256206559</c:v>
                </c:pt>
                <c:pt idx="5">
                  <c:v>10.2678252234359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80-427F-923D-F71B6BEB42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6014984"/>
        <c:axId val="516016296"/>
      </c:barChart>
      <c:catAx>
        <c:axId val="516014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16016296"/>
        <c:crosses val="autoZero"/>
        <c:auto val="1"/>
        <c:lblAlgn val="ctr"/>
        <c:lblOffset val="100"/>
        <c:noMultiLvlLbl val="0"/>
      </c:catAx>
      <c:valAx>
        <c:axId val="516016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16014984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66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8482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8238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2070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4775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670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3875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8995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789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389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8034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94BEF-AE69-4EB6-91A4-44D3BA7DB41C}" type="datetimeFigureOut">
              <a:rPr kumimoji="1" lang="ja-JP" altLang="en-US" smtClean="0"/>
              <a:t>2021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38C61A-8182-4C4B-8509-44A245E8B0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5818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g"/><Relationship Id="rId3" Type="http://schemas.openxmlformats.org/officeDocument/2006/relationships/chart" Target="../charts/chart2.xml"/><Relationship Id="rId7" Type="http://schemas.openxmlformats.org/officeDocument/2006/relationships/image" Target="../media/image4.jp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g"/><Relationship Id="rId5" Type="http://schemas.openxmlformats.org/officeDocument/2006/relationships/image" Target="../media/image2.jpg"/><Relationship Id="rId4" Type="http://schemas.openxmlformats.org/officeDocument/2006/relationships/image" Target="../media/image1.jpg"/><Relationship Id="rId9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"/><Relationship Id="rId3" Type="http://schemas.openxmlformats.org/officeDocument/2006/relationships/image" Target="../media/image11.tif"/><Relationship Id="rId7" Type="http://schemas.openxmlformats.org/officeDocument/2006/relationships/image" Target="../media/image15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"/><Relationship Id="rId5" Type="http://schemas.openxmlformats.org/officeDocument/2006/relationships/image" Target="../media/image13.tif"/><Relationship Id="rId10" Type="http://schemas.openxmlformats.org/officeDocument/2006/relationships/image" Target="../media/image18.tif"/><Relationship Id="rId4" Type="http://schemas.openxmlformats.org/officeDocument/2006/relationships/image" Target="../media/image12.tif"/><Relationship Id="rId9" Type="http://schemas.openxmlformats.org/officeDocument/2006/relationships/image" Target="../media/image17.ti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582E565-93EC-450A-BA99-E2269CFE8BF6}"/>
              </a:ext>
            </a:extLst>
          </p:cNvPr>
          <p:cNvSpPr txBox="1"/>
          <p:nvPr/>
        </p:nvSpPr>
        <p:spPr>
          <a:xfrm>
            <a:off x="5070088" y="113309"/>
            <a:ext cx="18714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</a:p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2EEDEE6A-3B8F-45EE-A74B-EF1D48CD08A5}"/>
              </a:ext>
            </a:extLst>
          </p:cNvPr>
          <p:cNvCxnSpPr>
            <a:cxnSpLocks/>
          </p:cNvCxnSpPr>
          <p:nvPr/>
        </p:nvCxnSpPr>
        <p:spPr>
          <a:xfrm>
            <a:off x="393702" y="2460647"/>
            <a:ext cx="5184000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76A1C0BF-041E-4BD6-A8F4-92A10E6ECA6B}"/>
              </a:ext>
            </a:extLst>
          </p:cNvPr>
          <p:cNvCxnSpPr>
            <a:cxnSpLocks/>
          </p:cNvCxnSpPr>
          <p:nvPr/>
        </p:nvCxnSpPr>
        <p:spPr>
          <a:xfrm>
            <a:off x="4275884" y="2226621"/>
            <a:ext cx="0" cy="46805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F08E4254-A16B-4591-91AB-86B8F945E3D5}"/>
              </a:ext>
            </a:extLst>
          </p:cNvPr>
          <p:cNvCxnSpPr>
            <a:cxnSpLocks/>
          </p:cNvCxnSpPr>
          <p:nvPr/>
        </p:nvCxnSpPr>
        <p:spPr>
          <a:xfrm>
            <a:off x="1744523" y="2226621"/>
            <a:ext cx="0" cy="46805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FCA58CE4-D7A8-452E-8435-623CED447B32}"/>
              </a:ext>
            </a:extLst>
          </p:cNvPr>
          <p:cNvCxnSpPr>
            <a:cxnSpLocks/>
          </p:cNvCxnSpPr>
          <p:nvPr/>
        </p:nvCxnSpPr>
        <p:spPr>
          <a:xfrm>
            <a:off x="2588310" y="2226621"/>
            <a:ext cx="0" cy="46805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03A72D4A-62E5-4117-8267-FD2FF7D3C7E8}"/>
              </a:ext>
            </a:extLst>
          </p:cNvPr>
          <p:cNvCxnSpPr>
            <a:cxnSpLocks/>
          </p:cNvCxnSpPr>
          <p:nvPr/>
        </p:nvCxnSpPr>
        <p:spPr>
          <a:xfrm>
            <a:off x="900736" y="2226621"/>
            <a:ext cx="0" cy="46805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DA3FE3F-92F6-48AC-A93E-8097D9873FA0}"/>
              </a:ext>
            </a:extLst>
          </p:cNvPr>
          <p:cNvSpPr txBox="1"/>
          <p:nvPr/>
        </p:nvSpPr>
        <p:spPr>
          <a:xfrm>
            <a:off x="214531" y="2684325"/>
            <a:ext cx="53030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eek    0                  1                  2                  3                 4                  5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下矢印 92">
            <a:extLst>
              <a:ext uri="{FF2B5EF4-FFF2-40B4-BE49-F238E27FC236}">
                <a16:creationId xmlns:a16="http://schemas.microsoft.com/office/drawing/2014/main" id="{38B2869F-711E-4EF3-8C8B-0B849BF071AD}"/>
              </a:ext>
            </a:extLst>
          </p:cNvPr>
          <p:cNvSpPr/>
          <p:nvPr/>
        </p:nvSpPr>
        <p:spPr>
          <a:xfrm>
            <a:off x="818327" y="1839796"/>
            <a:ext cx="187965" cy="354969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76C14FB-40B2-4AC3-A9D6-99F3E4390F0B}"/>
              </a:ext>
            </a:extLst>
          </p:cNvPr>
          <p:cNvSpPr txBox="1"/>
          <p:nvPr/>
        </p:nvSpPr>
        <p:spPr>
          <a:xfrm>
            <a:off x="475534" y="1549030"/>
            <a:ext cx="131070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noculation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7530AD8-0B76-465F-80F2-C951D17CA365}"/>
              </a:ext>
            </a:extLst>
          </p:cNvPr>
          <p:cNvSpPr txBox="1"/>
          <p:nvPr/>
        </p:nvSpPr>
        <p:spPr>
          <a:xfrm>
            <a:off x="1424414" y="713277"/>
            <a:ext cx="312111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umor size and weight measurement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E1289512-1F16-4792-BF86-C27FCB33A1D1}"/>
              </a:ext>
            </a:extLst>
          </p:cNvPr>
          <p:cNvCxnSpPr>
            <a:cxnSpLocks/>
            <a:stCxn id="12" idx="2"/>
          </p:cNvCxnSpPr>
          <p:nvPr/>
        </p:nvCxnSpPr>
        <p:spPr>
          <a:xfrm flipH="1">
            <a:off x="2626338" y="1021054"/>
            <a:ext cx="358632" cy="1023265"/>
          </a:xfrm>
          <a:prstGeom prst="straightConnector1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3D370B3F-2DD9-46C2-A3F8-BA17F6779B1C}"/>
              </a:ext>
            </a:extLst>
          </p:cNvPr>
          <p:cNvSpPr/>
          <p:nvPr/>
        </p:nvSpPr>
        <p:spPr>
          <a:xfrm>
            <a:off x="4573608" y="1412674"/>
            <a:ext cx="1092121" cy="300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crifice</a:t>
            </a:r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5122CA17-E31C-498D-AF82-F7B935B525E5}"/>
              </a:ext>
            </a:extLst>
          </p:cNvPr>
          <p:cNvCxnSpPr>
            <a:cxnSpLocks/>
          </p:cNvCxnSpPr>
          <p:nvPr/>
        </p:nvCxnSpPr>
        <p:spPr>
          <a:xfrm>
            <a:off x="5120945" y="1680006"/>
            <a:ext cx="0" cy="468053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7DAA9C56-D9BB-4CAA-8848-2826538A76BA}"/>
              </a:ext>
            </a:extLst>
          </p:cNvPr>
          <p:cNvCxnSpPr>
            <a:cxnSpLocks/>
            <a:stCxn id="12" idx="2"/>
          </p:cNvCxnSpPr>
          <p:nvPr/>
        </p:nvCxnSpPr>
        <p:spPr>
          <a:xfrm>
            <a:off x="2984970" y="1021054"/>
            <a:ext cx="431378" cy="1055952"/>
          </a:xfrm>
          <a:prstGeom prst="straightConnector1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3851B4DF-BD7E-41DB-83BD-AA2998F36E72}"/>
              </a:ext>
            </a:extLst>
          </p:cNvPr>
          <p:cNvCxnSpPr>
            <a:cxnSpLocks/>
          </p:cNvCxnSpPr>
          <p:nvPr/>
        </p:nvCxnSpPr>
        <p:spPr>
          <a:xfrm>
            <a:off x="3432097" y="2226621"/>
            <a:ext cx="0" cy="46805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5AA31421-CE33-4AB7-BEEE-CC751E740BF0}"/>
              </a:ext>
            </a:extLst>
          </p:cNvPr>
          <p:cNvCxnSpPr>
            <a:cxnSpLocks/>
            <a:stCxn id="12" idx="2"/>
          </p:cNvCxnSpPr>
          <p:nvPr/>
        </p:nvCxnSpPr>
        <p:spPr>
          <a:xfrm flipH="1">
            <a:off x="1810180" y="1021054"/>
            <a:ext cx="1174790" cy="1055952"/>
          </a:xfrm>
          <a:prstGeom prst="straightConnector1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CC55914E-6F3F-4A21-B1AC-2F2111A91D3C}"/>
              </a:ext>
            </a:extLst>
          </p:cNvPr>
          <p:cNvCxnSpPr>
            <a:cxnSpLocks/>
            <a:stCxn id="12" idx="2"/>
          </p:cNvCxnSpPr>
          <p:nvPr/>
        </p:nvCxnSpPr>
        <p:spPr>
          <a:xfrm>
            <a:off x="2984970" y="1021054"/>
            <a:ext cx="1277911" cy="1127005"/>
          </a:xfrm>
          <a:prstGeom prst="straightConnector1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6C468B47-18F4-4851-B398-7F7668E67450}"/>
              </a:ext>
            </a:extLst>
          </p:cNvPr>
          <p:cNvCxnSpPr>
            <a:cxnSpLocks/>
          </p:cNvCxnSpPr>
          <p:nvPr/>
        </p:nvCxnSpPr>
        <p:spPr>
          <a:xfrm flipV="1">
            <a:off x="1810180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5975FE3F-CF52-4314-8FC9-9FC6F07F15E8}"/>
              </a:ext>
            </a:extLst>
          </p:cNvPr>
          <p:cNvCxnSpPr>
            <a:cxnSpLocks/>
          </p:cNvCxnSpPr>
          <p:nvPr/>
        </p:nvCxnSpPr>
        <p:spPr>
          <a:xfrm flipV="1">
            <a:off x="2131673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A3DE9455-429F-409E-A4EA-D0786FDA01F8}"/>
              </a:ext>
            </a:extLst>
          </p:cNvPr>
          <p:cNvCxnSpPr>
            <a:cxnSpLocks/>
          </p:cNvCxnSpPr>
          <p:nvPr/>
        </p:nvCxnSpPr>
        <p:spPr>
          <a:xfrm flipV="1">
            <a:off x="2404260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D8739FDF-5DA0-4623-8BC7-1C7F7506F2B9}"/>
              </a:ext>
            </a:extLst>
          </p:cNvPr>
          <p:cNvCxnSpPr>
            <a:cxnSpLocks/>
          </p:cNvCxnSpPr>
          <p:nvPr/>
        </p:nvCxnSpPr>
        <p:spPr>
          <a:xfrm flipV="1">
            <a:off x="2653699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83B4BF02-A398-4A08-A7CD-9E7F624B2CD8}"/>
              </a:ext>
            </a:extLst>
          </p:cNvPr>
          <p:cNvCxnSpPr>
            <a:cxnSpLocks/>
          </p:cNvCxnSpPr>
          <p:nvPr/>
        </p:nvCxnSpPr>
        <p:spPr>
          <a:xfrm flipV="1">
            <a:off x="2903138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01EA1394-2F62-4C4F-B312-CC9772DC4FFA}"/>
              </a:ext>
            </a:extLst>
          </p:cNvPr>
          <p:cNvCxnSpPr>
            <a:cxnSpLocks/>
          </p:cNvCxnSpPr>
          <p:nvPr/>
        </p:nvCxnSpPr>
        <p:spPr>
          <a:xfrm flipV="1">
            <a:off x="3152577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F88A91A2-9C19-4E4D-8F79-72FF208C3A8C}"/>
              </a:ext>
            </a:extLst>
          </p:cNvPr>
          <p:cNvCxnSpPr>
            <a:cxnSpLocks/>
          </p:cNvCxnSpPr>
          <p:nvPr/>
        </p:nvCxnSpPr>
        <p:spPr>
          <a:xfrm flipV="1">
            <a:off x="3402016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38D3F956-31CB-401B-A449-048D7E54D8A5}"/>
              </a:ext>
            </a:extLst>
          </p:cNvPr>
          <p:cNvCxnSpPr>
            <a:cxnSpLocks/>
          </p:cNvCxnSpPr>
          <p:nvPr/>
        </p:nvCxnSpPr>
        <p:spPr>
          <a:xfrm flipV="1">
            <a:off x="3651455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5C0395B1-527F-4E56-AFFD-0002CABF13D7}"/>
              </a:ext>
            </a:extLst>
          </p:cNvPr>
          <p:cNvCxnSpPr>
            <a:cxnSpLocks/>
          </p:cNvCxnSpPr>
          <p:nvPr/>
        </p:nvCxnSpPr>
        <p:spPr>
          <a:xfrm flipV="1">
            <a:off x="3900894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D02B4E90-5938-4E86-9696-64C1559F5A6F}"/>
              </a:ext>
            </a:extLst>
          </p:cNvPr>
          <p:cNvCxnSpPr>
            <a:cxnSpLocks/>
          </p:cNvCxnSpPr>
          <p:nvPr/>
        </p:nvCxnSpPr>
        <p:spPr>
          <a:xfrm flipV="1">
            <a:off x="4150333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D4F67BD-3603-43D4-B272-B83300DC3175}"/>
              </a:ext>
            </a:extLst>
          </p:cNvPr>
          <p:cNvSpPr txBox="1"/>
          <p:nvPr/>
        </p:nvSpPr>
        <p:spPr>
          <a:xfrm>
            <a:off x="1836155" y="3344966"/>
            <a:ext cx="35178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hicle or APAM administration (every other day)</a:t>
            </a:r>
            <a:endParaRPr lang="ja-JP" altLang="en-US" sz="12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93CED421-548F-4503-A20F-5CC08077FCAD}"/>
              </a:ext>
            </a:extLst>
          </p:cNvPr>
          <p:cNvCxnSpPr>
            <a:cxnSpLocks/>
          </p:cNvCxnSpPr>
          <p:nvPr/>
        </p:nvCxnSpPr>
        <p:spPr>
          <a:xfrm>
            <a:off x="5119669" y="2226621"/>
            <a:ext cx="0" cy="46805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D2E6B57E-AE29-4BC1-8849-9E18453104BF}"/>
              </a:ext>
            </a:extLst>
          </p:cNvPr>
          <p:cNvCxnSpPr>
            <a:cxnSpLocks/>
          </p:cNvCxnSpPr>
          <p:nvPr/>
        </p:nvCxnSpPr>
        <p:spPr>
          <a:xfrm flipV="1">
            <a:off x="4399772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48433646-F4B3-45BC-AAC5-15F402571B4E}"/>
              </a:ext>
            </a:extLst>
          </p:cNvPr>
          <p:cNvCxnSpPr>
            <a:cxnSpLocks/>
          </p:cNvCxnSpPr>
          <p:nvPr/>
        </p:nvCxnSpPr>
        <p:spPr>
          <a:xfrm flipV="1">
            <a:off x="4649211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8EB9F1CB-7C0B-48E8-AE35-0B6E0974BF71}"/>
              </a:ext>
            </a:extLst>
          </p:cNvPr>
          <p:cNvCxnSpPr>
            <a:cxnSpLocks/>
          </p:cNvCxnSpPr>
          <p:nvPr/>
        </p:nvCxnSpPr>
        <p:spPr>
          <a:xfrm flipV="1">
            <a:off x="4898652" y="2964978"/>
            <a:ext cx="0" cy="362228"/>
          </a:xfrm>
          <a:prstGeom prst="straightConnector1">
            <a:avLst/>
          </a:prstGeom>
          <a:ln w="28575">
            <a:solidFill>
              <a:schemeClr val="accent2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1085DA1A-4381-44AF-9560-848BEDC426DD}"/>
              </a:ext>
            </a:extLst>
          </p:cNvPr>
          <p:cNvCxnSpPr>
            <a:cxnSpLocks/>
            <a:stCxn id="12" idx="2"/>
          </p:cNvCxnSpPr>
          <p:nvPr/>
        </p:nvCxnSpPr>
        <p:spPr>
          <a:xfrm>
            <a:off x="2984970" y="1021054"/>
            <a:ext cx="2032198" cy="1127005"/>
          </a:xfrm>
          <a:prstGeom prst="straightConnector1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52456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506542F7-E963-4728-B34C-411CB77CB612}"/>
              </a:ext>
            </a:extLst>
          </p:cNvPr>
          <p:cNvGraphicFramePr>
            <a:graphicFrameLocks/>
          </p:cNvGraphicFramePr>
          <p:nvPr/>
        </p:nvGraphicFramePr>
        <p:xfrm>
          <a:off x="601006" y="7143173"/>
          <a:ext cx="216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51401290-18D0-4871-89DB-085AC87970B5}"/>
              </a:ext>
            </a:extLst>
          </p:cNvPr>
          <p:cNvGraphicFramePr>
            <a:graphicFrameLocks/>
          </p:cNvGraphicFramePr>
          <p:nvPr/>
        </p:nvGraphicFramePr>
        <p:xfrm>
          <a:off x="3561243" y="7143173"/>
          <a:ext cx="216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4" name="図 3" descr="グラフィカル ユーザー インターフェイス が含まれている画像&#10;&#10;自動的に生成された説明">
            <a:extLst>
              <a:ext uri="{FF2B5EF4-FFF2-40B4-BE49-F238E27FC236}">
                <a16:creationId xmlns:a16="http://schemas.microsoft.com/office/drawing/2014/main" id="{33A55881-2A73-4D64-8459-EB2B0B8D265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618" y="5256919"/>
            <a:ext cx="1440000" cy="1508958"/>
          </a:xfrm>
          <a:prstGeom prst="rect">
            <a:avLst/>
          </a:prstGeom>
        </p:spPr>
      </p:pic>
      <p:pic>
        <p:nvPicPr>
          <p:cNvPr id="5" name="図 4" descr="グラフィカル ユーザー インターフェイス&#10;&#10;低い精度で自動的に生成された説明">
            <a:extLst>
              <a:ext uri="{FF2B5EF4-FFF2-40B4-BE49-F238E27FC236}">
                <a16:creationId xmlns:a16="http://schemas.microsoft.com/office/drawing/2014/main" id="{E4D43173-8AAA-4464-A022-18CF822AC29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9036" y="5267482"/>
            <a:ext cx="1296000" cy="1367556"/>
          </a:xfrm>
          <a:prstGeom prst="rect">
            <a:avLst/>
          </a:prstGeom>
        </p:spPr>
      </p:pic>
      <p:pic>
        <p:nvPicPr>
          <p:cNvPr id="6" name="図 5" descr="飛行機, 写真, フロント, 探す が含まれている画像&#10;&#10;自動的に生成された説明">
            <a:extLst>
              <a:ext uri="{FF2B5EF4-FFF2-40B4-BE49-F238E27FC236}">
                <a16:creationId xmlns:a16="http://schemas.microsoft.com/office/drawing/2014/main" id="{ACE8FA65-E414-4DDD-A07F-DBC98C98882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4217" y="3044971"/>
            <a:ext cx="1332000" cy="1675091"/>
          </a:xfrm>
          <a:prstGeom prst="rect">
            <a:avLst/>
          </a:prstGeom>
        </p:spPr>
      </p:pic>
      <p:pic>
        <p:nvPicPr>
          <p:cNvPr id="7" name="図 6" descr="写真, 食品, 飛行機, 鳥 が含まれている画像&#10;&#10;自動的に生成された説明">
            <a:extLst>
              <a:ext uri="{FF2B5EF4-FFF2-40B4-BE49-F238E27FC236}">
                <a16:creationId xmlns:a16="http://schemas.microsoft.com/office/drawing/2014/main" id="{5D6E944A-C92E-4A00-8D7B-5CA3BCA904A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3206" y="3042887"/>
            <a:ext cx="1368000" cy="1617435"/>
          </a:xfrm>
          <a:prstGeom prst="rect">
            <a:avLst/>
          </a:prstGeom>
        </p:spPr>
      </p:pic>
      <p:pic>
        <p:nvPicPr>
          <p:cNvPr id="8" name="図 7" descr="屋外, 水, 男, 雪 が含まれている画像&#10;&#10;自動的に生成された説明">
            <a:extLst>
              <a:ext uri="{FF2B5EF4-FFF2-40B4-BE49-F238E27FC236}">
                <a16:creationId xmlns:a16="http://schemas.microsoft.com/office/drawing/2014/main" id="{2847F5A0-463B-42EB-BA7A-2644FB2319C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613" y="864715"/>
            <a:ext cx="1385564" cy="1698556"/>
          </a:xfrm>
          <a:prstGeom prst="rect">
            <a:avLst/>
          </a:prstGeom>
        </p:spPr>
      </p:pic>
      <p:pic>
        <p:nvPicPr>
          <p:cNvPr id="9" name="図 8" descr="屋外, 砂浜, 男, 民衆 が含まれている画像&#10;&#10;自動的に生成された説明">
            <a:extLst>
              <a:ext uri="{FF2B5EF4-FFF2-40B4-BE49-F238E27FC236}">
                <a16:creationId xmlns:a16="http://schemas.microsoft.com/office/drawing/2014/main" id="{C984D576-81EF-4C63-A8E4-DF0F414F1ED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9203" y="864715"/>
            <a:ext cx="1368000" cy="1649437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FA1D4B5-872F-4D0C-B756-CF6598C67167}"/>
              </a:ext>
            </a:extLst>
          </p:cNvPr>
          <p:cNvSpPr txBox="1"/>
          <p:nvPr/>
        </p:nvSpPr>
        <p:spPr>
          <a:xfrm>
            <a:off x="39377" y="285526"/>
            <a:ext cx="3791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A5230E8-1476-4AC5-AF3A-4E812E5B5B21}"/>
              </a:ext>
            </a:extLst>
          </p:cNvPr>
          <p:cNvSpPr txBox="1"/>
          <p:nvPr/>
        </p:nvSpPr>
        <p:spPr>
          <a:xfrm>
            <a:off x="89036" y="6973895"/>
            <a:ext cx="3791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2B626B7D-FDEB-4A54-8A93-3ABE3385EDE0}"/>
              </a:ext>
            </a:extLst>
          </p:cNvPr>
          <p:cNvSpPr/>
          <p:nvPr/>
        </p:nvSpPr>
        <p:spPr>
          <a:xfrm>
            <a:off x="911194" y="381647"/>
            <a:ext cx="1187814" cy="225404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APAM (50 %)</a:t>
            </a: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EEEFB351-6D3C-4D1C-AD83-C0E5AA491ED8}"/>
              </a:ext>
            </a:extLst>
          </p:cNvPr>
          <p:cNvSpPr/>
          <p:nvPr/>
        </p:nvSpPr>
        <p:spPr>
          <a:xfrm>
            <a:off x="763455" y="586123"/>
            <a:ext cx="1695898" cy="307043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4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1     6    12    24   (h)</a:t>
            </a: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6406822F-D8BC-48C8-A8F8-77EB7CE8E5C0}"/>
              </a:ext>
            </a:extLst>
          </p:cNvPr>
          <p:cNvCxnSpPr>
            <a:cxnSpLocks/>
          </p:cNvCxnSpPr>
          <p:nvPr/>
        </p:nvCxnSpPr>
        <p:spPr>
          <a:xfrm>
            <a:off x="793113" y="626701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2AE0C85-C931-48E8-AC20-44826C56AA08}"/>
              </a:ext>
            </a:extLst>
          </p:cNvPr>
          <p:cNvSpPr txBox="1"/>
          <p:nvPr/>
        </p:nvSpPr>
        <p:spPr>
          <a:xfrm>
            <a:off x="308399" y="380078"/>
            <a:ext cx="51551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LM8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FB3F6DA-FC06-4657-8335-FDFC87400D94}"/>
              </a:ext>
            </a:extLst>
          </p:cNvPr>
          <p:cNvSpPr txBox="1"/>
          <p:nvPr/>
        </p:nvSpPr>
        <p:spPr>
          <a:xfrm>
            <a:off x="3329922" y="380078"/>
            <a:ext cx="89826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43B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A23CDC8-53AF-44C2-9197-7FE7B7612473}"/>
              </a:ext>
            </a:extLst>
          </p:cNvPr>
          <p:cNvSpPr txBox="1"/>
          <p:nvPr/>
        </p:nvSpPr>
        <p:spPr>
          <a:xfrm>
            <a:off x="2318516" y="2064770"/>
            <a:ext cx="89276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leaved Caspase 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10D5EDAC-4C07-42FF-89B7-8281953BCF80}"/>
              </a:ext>
            </a:extLst>
          </p:cNvPr>
          <p:cNvCxnSpPr>
            <a:cxnSpLocks/>
          </p:cNvCxnSpPr>
          <p:nvPr/>
        </p:nvCxnSpPr>
        <p:spPr>
          <a:xfrm flipH="1">
            <a:off x="2169560" y="2270115"/>
            <a:ext cx="216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2C01911C-C114-478D-83F5-639FBA71821A}"/>
              </a:ext>
            </a:extLst>
          </p:cNvPr>
          <p:cNvCxnSpPr>
            <a:cxnSpLocks/>
          </p:cNvCxnSpPr>
          <p:nvPr/>
        </p:nvCxnSpPr>
        <p:spPr>
          <a:xfrm flipH="1">
            <a:off x="5291272" y="2188450"/>
            <a:ext cx="216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DEAFCED-E18F-4D69-B7CE-8901CD4C4ED9}"/>
              </a:ext>
            </a:extLst>
          </p:cNvPr>
          <p:cNvSpPr txBox="1"/>
          <p:nvPr/>
        </p:nvSpPr>
        <p:spPr>
          <a:xfrm>
            <a:off x="380283" y="231030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DBF2ECA-7EB3-458A-A9D0-B458B8150822}"/>
              </a:ext>
            </a:extLst>
          </p:cNvPr>
          <p:cNvSpPr txBox="1"/>
          <p:nvPr/>
        </p:nvSpPr>
        <p:spPr>
          <a:xfrm>
            <a:off x="380283" y="199029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F862008-F012-48A0-B8D5-241E9C6D2676}"/>
              </a:ext>
            </a:extLst>
          </p:cNvPr>
          <p:cNvSpPr txBox="1"/>
          <p:nvPr/>
        </p:nvSpPr>
        <p:spPr>
          <a:xfrm>
            <a:off x="380283" y="141264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4306E5D-16A3-4677-9827-576E7163E818}"/>
              </a:ext>
            </a:extLst>
          </p:cNvPr>
          <p:cNvSpPr txBox="1"/>
          <p:nvPr/>
        </p:nvSpPr>
        <p:spPr>
          <a:xfrm>
            <a:off x="2484359" y="887936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A5EB034-B3ED-446A-B073-E5C5DE88D06D}"/>
              </a:ext>
            </a:extLst>
          </p:cNvPr>
          <p:cNvSpPr txBox="1"/>
          <p:nvPr/>
        </p:nvSpPr>
        <p:spPr>
          <a:xfrm>
            <a:off x="911748" y="7020062"/>
            <a:ext cx="16674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leaved Caspase 3 (LM8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0A1FE89-0D76-4ABC-8A3B-45D398D42F1E}"/>
              </a:ext>
            </a:extLst>
          </p:cNvPr>
          <p:cNvSpPr txBox="1"/>
          <p:nvPr/>
        </p:nvSpPr>
        <p:spPr>
          <a:xfrm rot="16200000">
            <a:off x="-400336" y="7924971"/>
            <a:ext cx="18245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(% area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944D058-7793-4DE6-A7DD-110DD94F6676}"/>
              </a:ext>
            </a:extLst>
          </p:cNvPr>
          <p:cNvSpPr txBox="1"/>
          <p:nvPr/>
        </p:nvSpPr>
        <p:spPr>
          <a:xfrm rot="16200000">
            <a:off x="2589928" y="7924971"/>
            <a:ext cx="18245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(% area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0D33A00-4710-4354-A011-EA27A2BB24CC}"/>
              </a:ext>
            </a:extLst>
          </p:cNvPr>
          <p:cNvSpPr txBox="1"/>
          <p:nvPr/>
        </p:nvSpPr>
        <p:spPr>
          <a:xfrm>
            <a:off x="5440919" y="887936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B6F3B5A-24A6-4CD1-B3EA-D7BABFB320EC}"/>
              </a:ext>
            </a:extLst>
          </p:cNvPr>
          <p:cNvSpPr txBox="1"/>
          <p:nvPr/>
        </p:nvSpPr>
        <p:spPr>
          <a:xfrm>
            <a:off x="3822588" y="7020062"/>
            <a:ext cx="17155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leaved Caspase 3 (143B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42381531-792F-4809-A0A8-9BD1BB29EAF8}"/>
              </a:ext>
            </a:extLst>
          </p:cNvPr>
          <p:cNvSpPr/>
          <p:nvPr/>
        </p:nvSpPr>
        <p:spPr>
          <a:xfrm>
            <a:off x="4016344" y="381647"/>
            <a:ext cx="1187814" cy="225404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APAM (50 %)</a:t>
            </a: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E7491383-CD29-48AF-A849-63B9FE821003}"/>
              </a:ext>
            </a:extLst>
          </p:cNvPr>
          <p:cNvSpPr/>
          <p:nvPr/>
        </p:nvSpPr>
        <p:spPr>
          <a:xfrm>
            <a:off x="3868605" y="586123"/>
            <a:ext cx="1695898" cy="307043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4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1     6    12    24   (h)</a:t>
            </a: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077D4F85-CE48-4B60-A788-0CE6CE3D6E64}"/>
              </a:ext>
            </a:extLst>
          </p:cNvPr>
          <p:cNvCxnSpPr>
            <a:cxnSpLocks/>
          </p:cNvCxnSpPr>
          <p:nvPr/>
        </p:nvCxnSpPr>
        <p:spPr>
          <a:xfrm>
            <a:off x="3898263" y="626701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0A25180-2693-4ADA-9705-B3DF06FD876E}"/>
              </a:ext>
            </a:extLst>
          </p:cNvPr>
          <p:cNvSpPr txBox="1"/>
          <p:nvPr/>
        </p:nvSpPr>
        <p:spPr>
          <a:xfrm>
            <a:off x="5435225" y="2016760"/>
            <a:ext cx="89276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leaved Caspase 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B122452-83BA-4DB0-AD79-D6B30B3D6C7E}"/>
              </a:ext>
            </a:extLst>
          </p:cNvPr>
          <p:cNvSpPr txBox="1"/>
          <p:nvPr/>
        </p:nvSpPr>
        <p:spPr>
          <a:xfrm>
            <a:off x="391870" y="92560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E749609-86BC-4EDC-869D-F12EABCAD4A9}"/>
              </a:ext>
            </a:extLst>
          </p:cNvPr>
          <p:cNvSpPr txBox="1"/>
          <p:nvPr/>
        </p:nvSpPr>
        <p:spPr>
          <a:xfrm>
            <a:off x="3496863" y="226458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23B8E05E-4E6B-4A62-902E-132B23D2B518}"/>
              </a:ext>
            </a:extLst>
          </p:cNvPr>
          <p:cNvSpPr txBox="1"/>
          <p:nvPr/>
        </p:nvSpPr>
        <p:spPr>
          <a:xfrm>
            <a:off x="3496863" y="194457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7786930-3B70-4A00-87D1-434755BF758D}"/>
              </a:ext>
            </a:extLst>
          </p:cNvPr>
          <p:cNvSpPr txBox="1"/>
          <p:nvPr/>
        </p:nvSpPr>
        <p:spPr>
          <a:xfrm>
            <a:off x="3496863" y="136692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A318085-DC10-4B83-BB16-74FA2D99C9E4}"/>
              </a:ext>
            </a:extLst>
          </p:cNvPr>
          <p:cNvSpPr txBox="1"/>
          <p:nvPr/>
        </p:nvSpPr>
        <p:spPr>
          <a:xfrm>
            <a:off x="3508450" y="87988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7F1ED34A-AD75-4A54-922E-1D46DDF62030}"/>
              </a:ext>
            </a:extLst>
          </p:cNvPr>
          <p:cNvSpPr/>
          <p:nvPr/>
        </p:nvSpPr>
        <p:spPr>
          <a:xfrm>
            <a:off x="911194" y="2568587"/>
            <a:ext cx="1187814" cy="225404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APAM (50 %)</a:t>
            </a: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7D724896-5C5E-4113-977B-E8B8E8FE6699}"/>
              </a:ext>
            </a:extLst>
          </p:cNvPr>
          <p:cNvSpPr/>
          <p:nvPr/>
        </p:nvSpPr>
        <p:spPr>
          <a:xfrm>
            <a:off x="763455" y="2773063"/>
            <a:ext cx="1695898" cy="307043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4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1     6    12    24   (h)</a:t>
            </a: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E12A29DC-22E5-4759-9934-99E84D173F2D}"/>
              </a:ext>
            </a:extLst>
          </p:cNvPr>
          <p:cNvCxnSpPr>
            <a:cxnSpLocks/>
          </p:cNvCxnSpPr>
          <p:nvPr/>
        </p:nvCxnSpPr>
        <p:spPr>
          <a:xfrm>
            <a:off x="793113" y="2813641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0925DEC-26A9-45C5-94C8-F551B464CED6}"/>
              </a:ext>
            </a:extLst>
          </p:cNvPr>
          <p:cNvSpPr txBox="1"/>
          <p:nvPr/>
        </p:nvSpPr>
        <p:spPr>
          <a:xfrm>
            <a:off x="308399" y="2567018"/>
            <a:ext cx="51551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LM8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8933C1FC-8B21-40A5-8459-CABD9C54449A}"/>
              </a:ext>
            </a:extLst>
          </p:cNvPr>
          <p:cNvSpPr txBox="1"/>
          <p:nvPr/>
        </p:nvSpPr>
        <p:spPr>
          <a:xfrm>
            <a:off x="3329922" y="2567018"/>
            <a:ext cx="89826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43B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02C327E-D5BF-420E-86BC-D881E75895BA}"/>
              </a:ext>
            </a:extLst>
          </p:cNvPr>
          <p:cNvSpPr txBox="1"/>
          <p:nvPr/>
        </p:nvSpPr>
        <p:spPr>
          <a:xfrm>
            <a:off x="2318516" y="3466850"/>
            <a:ext cx="89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FC5A49D7-A9E9-46CF-B6D1-A261B4B2B7F1}"/>
              </a:ext>
            </a:extLst>
          </p:cNvPr>
          <p:cNvCxnSpPr>
            <a:cxnSpLocks/>
          </p:cNvCxnSpPr>
          <p:nvPr/>
        </p:nvCxnSpPr>
        <p:spPr>
          <a:xfrm flipH="1">
            <a:off x="2169560" y="3603615"/>
            <a:ext cx="216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3C9BEC13-8C25-432B-8535-D5E2C322B564}"/>
              </a:ext>
            </a:extLst>
          </p:cNvPr>
          <p:cNvCxnSpPr>
            <a:cxnSpLocks/>
          </p:cNvCxnSpPr>
          <p:nvPr/>
        </p:nvCxnSpPr>
        <p:spPr>
          <a:xfrm flipH="1">
            <a:off x="5291272" y="3560050"/>
            <a:ext cx="216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93666EA-22CE-4C46-B3A3-074749077538}"/>
              </a:ext>
            </a:extLst>
          </p:cNvPr>
          <p:cNvSpPr txBox="1"/>
          <p:nvPr/>
        </p:nvSpPr>
        <p:spPr>
          <a:xfrm>
            <a:off x="380283" y="439818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75A843CA-3538-4AF6-A18E-F1A33845873D}"/>
              </a:ext>
            </a:extLst>
          </p:cNvPr>
          <p:cNvSpPr txBox="1"/>
          <p:nvPr/>
        </p:nvSpPr>
        <p:spPr>
          <a:xfrm>
            <a:off x="380283" y="407817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B2BEE36-515F-4E16-AF47-F6DDE1F06D2E}"/>
              </a:ext>
            </a:extLst>
          </p:cNvPr>
          <p:cNvSpPr txBox="1"/>
          <p:nvPr/>
        </p:nvSpPr>
        <p:spPr>
          <a:xfrm>
            <a:off x="380283" y="347004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755BD6CE-F9B7-49CF-AAAB-2D7491B00950}"/>
              </a:ext>
            </a:extLst>
          </p:cNvPr>
          <p:cNvSpPr/>
          <p:nvPr/>
        </p:nvSpPr>
        <p:spPr>
          <a:xfrm>
            <a:off x="4016344" y="2568587"/>
            <a:ext cx="1187814" cy="225404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APAM (50 %)</a:t>
            </a: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C50FDD32-7675-4204-B2C5-20F8087DA25E}"/>
              </a:ext>
            </a:extLst>
          </p:cNvPr>
          <p:cNvSpPr/>
          <p:nvPr/>
        </p:nvSpPr>
        <p:spPr>
          <a:xfrm>
            <a:off x="3868605" y="2773063"/>
            <a:ext cx="1695898" cy="307043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4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1     6    12    24   (h)</a:t>
            </a: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49380AFE-886C-4EF4-A5C8-B7EEC08F9D54}"/>
              </a:ext>
            </a:extLst>
          </p:cNvPr>
          <p:cNvCxnSpPr>
            <a:cxnSpLocks/>
          </p:cNvCxnSpPr>
          <p:nvPr/>
        </p:nvCxnSpPr>
        <p:spPr>
          <a:xfrm>
            <a:off x="3898263" y="2813641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BFD995CE-C3D1-486F-9900-0228CEB6F4E5}"/>
              </a:ext>
            </a:extLst>
          </p:cNvPr>
          <p:cNvSpPr txBox="1"/>
          <p:nvPr/>
        </p:nvSpPr>
        <p:spPr>
          <a:xfrm>
            <a:off x="5458375" y="3414304"/>
            <a:ext cx="89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872C0776-E6E0-4EEF-9E15-369E7B0EAC0E}"/>
              </a:ext>
            </a:extLst>
          </p:cNvPr>
          <p:cNvSpPr txBox="1"/>
          <p:nvPr/>
        </p:nvSpPr>
        <p:spPr>
          <a:xfrm>
            <a:off x="391870" y="300586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9B5EB5DA-E91D-47E1-A68F-FED545D38ABE}"/>
              </a:ext>
            </a:extLst>
          </p:cNvPr>
          <p:cNvSpPr txBox="1"/>
          <p:nvPr/>
        </p:nvSpPr>
        <p:spPr>
          <a:xfrm>
            <a:off x="3504483" y="439818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61277616-E18F-4B75-AD4C-F460C4671D7D}"/>
              </a:ext>
            </a:extLst>
          </p:cNvPr>
          <p:cNvSpPr txBox="1"/>
          <p:nvPr/>
        </p:nvSpPr>
        <p:spPr>
          <a:xfrm>
            <a:off x="3504483" y="407817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EB87BCB-3A67-40FD-8DAC-8F2CDD7E2DA4}"/>
              </a:ext>
            </a:extLst>
          </p:cNvPr>
          <p:cNvSpPr txBox="1"/>
          <p:nvPr/>
        </p:nvSpPr>
        <p:spPr>
          <a:xfrm>
            <a:off x="3504483" y="347004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87BB9597-D9A1-4129-A016-8B4FE77CA80E}"/>
              </a:ext>
            </a:extLst>
          </p:cNvPr>
          <p:cNvSpPr txBox="1"/>
          <p:nvPr/>
        </p:nvSpPr>
        <p:spPr>
          <a:xfrm>
            <a:off x="3516070" y="300586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F1EE6439-4853-40F1-BC5C-51E08D54EBFB}"/>
              </a:ext>
            </a:extLst>
          </p:cNvPr>
          <p:cNvSpPr/>
          <p:nvPr/>
        </p:nvSpPr>
        <p:spPr>
          <a:xfrm>
            <a:off x="911194" y="4768862"/>
            <a:ext cx="1187814" cy="225404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APAM (50 %)</a:t>
            </a: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FFF6706A-0D1B-4D57-AD47-A8F4EFF54851}"/>
              </a:ext>
            </a:extLst>
          </p:cNvPr>
          <p:cNvSpPr/>
          <p:nvPr/>
        </p:nvSpPr>
        <p:spPr>
          <a:xfrm>
            <a:off x="763455" y="4973338"/>
            <a:ext cx="1695898" cy="307043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4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1     6    12    24   (h)</a:t>
            </a:r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80696B86-6050-46BB-9D63-36C1D9262DB9}"/>
              </a:ext>
            </a:extLst>
          </p:cNvPr>
          <p:cNvCxnSpPr>
            <a:cxnSpLocks/>
          </p:cNvCxnSpPr>
          <p:nvPr/>
        </p:nvCxnSpPr>
        <p:spPr>
          <a:xfrm>
            <a:off x="793113" y="5013916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37F8B544-0DE4-4FC0-B861-EF014FA05DE0}"/>
              </a:ext>
            </a:extLst>
          </p:cNvPr>
          <p:cNvSpPr txBox="1"/>
          <p:nvPr/>
        </p:nvSpPr>
        <p:spPr>
          <a:xfrm>
            <a:off x="308399" y="4767293"/>
            <a:ext cx="51551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LM8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8DF8BAD9-9A53-4EF5-B156-161AE77844C5}"/>
              </a:ext>
            </a:extLst>
          </p:cNvPr>
          <p:cNvSpPr txBox="1"/>
          <p:nvPr/>
        </p:nvSpPr>
        <p:spPr>
          <a:xfrm>
            <a:off x="3329922" y="4767293"/>
            <a:ext cx="89826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43B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26772DC5-2D89-4ECA-9F8C-CB520589E252}"/>
              </a:ext>
            </a:extLst>
          </p:cNvPr>
          <p:cNvSpPr txBox="1"/>
          <p:nvPr/>
        </p:nvSpPr>
        <p:spPr>
          <a:xfrm>
            <a:off x="2337566" y="5571870"/>
            <a:ext cx="89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直線矢印コネクタ 63">
            <a:extLst>
              <a:ext uri="{FF2B5EF4-FFF2-40B4-BE49-F238E27FC236}">
                <a16:creationId xmlns:a16="http://schemas.microsoft.com/office/drawing/2014/main" id="{EC2C168C-F86A-4B62-9BA1-4C29AF8F0682}"/>
              </a:ext>
            </a:extLst>
          </p:cNvPr>
          <p:cNvCxnSpPr>
            <a:cxnSpLocks/>
          </p:cNvCxnSpPr>
          <p:nvPr/>
        </p:nvCxnSpPr>
        <p:spPr>
          <a:xfrm flipH="1">
            <a:off x="2169560" y="5708635"/>
            <a:ext cx="216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矢印コネクタ 64">
            <a:extLst>
              <a:ext uri="{FF2B5EF4-FFF2-40B4-BE49-F238E27FC236}">
                <a16:creationId xmlns:a16="http://schemas.microsoft.com/office/drawing/2014/main" id="{6F5EB708-F8F2-47A6-AB3D-6ACBD0817755}"/>
              </a:ext>
            </a:extLst>
          </p:cNvPr>
          <p:cNvCxnSpPr>
            <a:cxnSpLocks/>
          </p:cNvCxnSpPr>
          <p:nvPr/>
        </p:nvCxnSpPr>
        <p:spPr>
          <a:xfrm flipH="1">
            <a:off x="5257931" y="5726984"/>
            <a:ext cx="216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4C1DDC72-2E67-4188-85CA-7E24CAFE2B89}"/>
              </a:ext>
            </a:extLst>
          </p:cNvPr>
          <p:cNvSpPr txBox="1"/>
          <p:nvPr/>
        </p:nvSpPr>
        <p:spPr>
          <a:xfrm>
            <a:off x="380283" y="6507971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5403690E-7BEC-410B-8568-6A65B554DB87}"/>
              </a:ext>
            </a:extLst>
          </p:cNvPr>
          <p:cNvSpPr txBox="1"/>
          <p:nvPr/>
        </p:nvSpPr>
        <p:spPr>
          <a:xfrm>
            <a:off x="380283" y="6187959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53BB4DF-CC0F-47D2-AD10-B05FE79CF4C2}"/>
              </a:ext>
            </a:extLst>
          </p:cNvPr>
          <p:cNvSpPr txBox="1"/>
          <p:nvPr/>
        </p:nvSpPr>
        <p:spPr>
          <a:xfrm>
            <a:off x="380283" y="560364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F53CCB00-C4B0-42AD-B783-56038ECB3FAE}"/>
              </a:ext>
            </a:extLst>
          </p:cNvPr>
          <p:cNvSpPr/>
          <p:nvPr/>
        </p:nvSpPr>
        <p:spPr>
          <a:xfrm>
            <a:off x="4016344" y="4768862"/>
            <a:ext cx="1187814" cy="225404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APAM (50 %)</a:t>
            </a: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E369D4F2-44D6-4D75-9889-656DDF3C8DC7}"/>
              </a:ext>
            </a:extLst>
          </p:cNvPr>
          <p:cNvSpPr/>
          <p:nvPr/>
        </p:nvSpPr>
        <p:spPr>
          <a:xfrm>
            <a:off x="3868605" y="4973338"/>
            <a:ext cx="1695898" cy="307043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4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1     6    12    24   (h)</a:t>
            </a:r>
          </a:p>
        </p:txBody>
      </p: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95B49E02-0B24-4651-B97B-4167752F32C7}"/>
              </a:ext>
            </a:extLst>
          </p:cNvPr>
          <p:cNvCxnSpPr>
            <a:cxnSpLocks/>
          </p:cNvCxnSpPr>
          <p:nvPr/>
        </p:nvCxnSpPr>
        <p:spPr>
          <a:xfrm>
            <a:off x="3898263" y="5013916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C86CD938-CB4B-495A-9955-27A44BC9E4F9}"/>
              </a:ext>
            </a:extLst>
          </p:cNvPr>
          <p:cNvSpPr txBox="1"/>
          <p:nvPr/>
        </p:nvSpPr>
        <p:spPr>
          <a:xfrm>
            <a:off x="391870" y="5206140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26D0BE5B-B16E-433A-9ACB-4DAEF01EB193}"/>
              </a:ext>
            </a:extLst>
          </p:cNvPr>
          <p:cNvSpPr txBox="1"/>
          <p:nvPr/>
        </p:nvSpPr>
        <p:spPr>
          <a:xfrm>
            <a:off x="3504483" y="6507971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F2B6CE07-FE77-4EBA-A145-094241A65C96}"/>
              </a:ext>
            </a:extLst>
          </p:cNvPr>
          <p:cNvSpPr txBox="1"/>
          <p:nvPr/>
        </p:nvSpPr>
        <p:spPr>
          <a:xfrm>
            <a:off x="3504483" y="6187959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6727C5D6-77D3-41E3-8935-0CAC281F626C}"/>
              </a:ext>
            </a:extLst>
          </p:cNvPr>
          <p:cNvSpPr txBox="1"/>
          <p:nvPr/>
        </p:nvSpPr>
        <p:spPr>
          <a:xfrm>
            <a:off x="3504483" y="560364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1B3BEF4-FACA-49BD-B7EB-44F749AECABB}"/>
              </a:ext>
            </a:extLst>
          </p:cNvPr>
          <p:cNvSpPr txBox="1"/>
          <p:nvPr/>
        </p:nvSpPr>
        <p:spPr>
          <a:xfrm>
            <a:off x="3516070" y="5206140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FA04E573-BCC5-4829-8D7C-3B6DD7C0FE8D}"/>
              </a:ext>
            </a:extLst>
          </p:cNvPr>
          <p:cNvSpPr txBox="1"/>
          <p:nvPr/>
        </p:nvSpPr>
        <p:spPr>
          <a:xfrm>
            <a:off x="5418900" y="5595684"/>
            <a:ext cx="89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D25E5D81-AB34-4302-9773-0883BA296ADA}"/>
              </a:ext>
            </a:extLst>
          </p:cNvPr>
          <p:cNvSpPr txBox="1"/>
          <p:nvPr/>
        </p:nvSpPr>
        <p:spPr>
          <a:xfrm>
            <a:off x="5070088" y="113309"/>
            <a:ext cx="18714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</a:p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6B81D312-6E90-4A02-B5A0-2A90F8AC46F2}"/>
              </a:ext>
            </a:extLst>
          </p:cNvPr>
          <p:cNvSpPr txBox="1"/>
          <p:nvPr/>
        </p:nvSpPr>
        <p:spPr>
          <a:xfrm>
            <a:off x="377506" y="652910"/>
            <a:ext cx="51551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993C567D-D480-4B51-907E-F70E64DF8D0F}"/>
              </a:ext>
            </a:extLst>
          </p:cNvPr>
          <p:cNvSpPr txBox="1"/>
          <p:nvPr/>
        </p:nvSpPr>
        <p:spPr>
          <a:xfrm>
            <a:off x="3489246" y="612644"/>
            <a:ext cx="51551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B617F113-67A7-46B3-A8AC-2E3406CEE77C}"/>
              </a:ext>
            </a:extLst>
          </p:cNvPr>
          <p:cNvSpPr txBox="1"/>
          <p:nvPr/>
        </p:nvSpPr>
        <p:spPr>
          <a:xfrm>
            <a:off x="373177" y="2815489"/>
            <a:ext cx="51551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937C981B-D18A-4BDF-977D-F768ED2E89B0}"/>
              </a:ext>
            </a:extLst>
          </p:cNvPr>
          <p:cNvSpPr txBox="1"/>
          <p:nvPr/>
        </p:nvSpPr>
        <p:spPr>
          <a:xfrm>
            <a:off x="3479417" y="2813902"/>
            <a:ext cx="51551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3A50220C-4768-476F-B815-F01FAFE1E719}"/>
              </a:ext>
            </a:extLst>
          </p:cNvPr>
          <p:cNvSpPr txBox="1"/>
          <p:nvPr/>
        </p:nvSpPr>
        <p:spPr>
          <a:xfrm>
            <a:off x="373177" y="5015912"/>
            <a:ext cx="51551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9DD0BAB6-C405-4747-9446-FCE1CF908E23}"/>
              </a:ext>
            </a:extLst>
          </p:cNvPr>
          <p:cNvSpPr txBox="1"/>
          <p:nvPr/>
        </p:nvSpPr>
        <p:spPr>
          <a:xfrm>
            <a:off x="3489246" y="4980414"/>
            <a:ext cx="51551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1948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B71E61F-F37E-4AF3-8E61-E8F55CD1FD6D}"/>
              </a:ext>
            </a:extLst>
          </p:cNvPr>
          <p:cNvSpPr txBox="1"/>
          <p:nvPr/>
        </p:nvSpPr>
        <p:spPr>
          <a:xfrm>
            <a:off x="5070088" y="113309"/>
            <a:ext cx="18714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</a:p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 descr="背景パターン が含まれている画像&#10;&#10;自動的に生成された説明">
            <a:extLst>
              <a:ext uri="{FF2B5EF4-FFF2-40B4-BE49-F238E27FC236}">
                <a16:creationId xmlns:a16="http://schemas.microsoft.com/office/drawing/2014/main" id="{E871FD81-53AE-4126-B6F6-2FC8CC3AC2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453" y="3867918"/>
            <a:ext cx="2047541" cy="1841783"/>
          </a:xfrm>
          <a:prstGeom prst="rect">
            <a:avLst/>
          </a:prstGeom>
        </p:spPr>
      </p:pic>
      <p:pic>
        <p:nvPicPr>
          <p:cNvPr id="4" name="図 3" descr="黒い背景と白い文字&#10;&#10;自動的に生成された説明">
            <a:extLst>
              <a:ext uri="{FF2B5EF4-FFF2-40B4-BE49-F238E27FC236}">
                <a16:creationId xmlns:a16="http://schemas.microsoft.com/office/drawing/2014/main" id="{67CFE448-97B0-4CD7-B6FA-36D3E751B0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510" y="1238854"/>
            <a:ext cx="2087315" cy="1725326"/>
          </a:xfrm>
          <a:prstGeom prst="rect">
            <a:avLst/>
          </a:prstGeom>
        </p:spPr>
      </p:pic>
      <p:pic>
        <p:nvPicPr>
          <p:cNvPr id="5" name="図 4" descr="黒い背景と白い文字&#10;&#10;自動的に生成された説明">
            <a:extLst>
              <a:ext uri="{FF2B5EF4-FFF2-40B4-BE49-F238E27FC236}">
                <a16:creationId xmlns:a16="http://schemas.microsoft.com/office/drawing/2014/main" id="{AA58DB2A-ADAF-4132-A584-A4345391B17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3524" y="1252393"/>
            <a:ext cx="2047541" cy="1904114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435B2F3-8554-4A53-9A19-F4961C94BBC3}"/>
              </a:ext>
            </a:extLst>
          </p:cNvPr>
          <p:cNvSpPr txBox="1"/>
          <p:nvPr/>
        </p:nvSpPr>
        <p:spPr>
          <a:xfrm>
            <a:off x="39377" y="511586"/>
            <a:ext cx="3791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39FECDB-A150-4510-A0AA-FDC7AD973DC9}"/>
              </a:ext>
            </a:extLst>
          </p:cNvPr>
          <p:cNvSpPr txBox="1"/>
          <p:nvPr/>
        </p:nvSpPr>
        <p:spPr>
          <a:xfrm>
            <a:off x="39242" y="5991681"/>
            <a:ext cx="3791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A1A32237-5309-4F68-8068-88E88A5F2172}"/>
              </a:ext>
            </a:extLst>
          </p:cNvPr>
          <p:cNvSpPr/>
          <p:nvPr/>
        </p:nvSpPr>
        <p:spPr>
          <a:xfrm>
            <a:off x="469536" y="690503"/>
            <a:ext cx="2592288" cy="561372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PAM (50 %)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3A2AF574-D964-4EC5-9159-B404933F5A5C}"/>
              </a:ext>
            </a:extLst>
          </p:cNvPr>
          <p:cNvSpPr/>
          <p:nvPr/>
        </p:nvSpPr>
        <p:spPr>
          <a:xfrm>
            <a:off x="694877" y="952193"/>
            <a:ext cx="2207244" cy="307043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4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  1       6      12      24     48 (h)</a:t>
            </a: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9AE4FD23-E62A-43A6-A933-C1E28289B756}"/>
              </a:ext>
            </a:extLst>
          </p:cNvPr>
          <p:cNvCxnSpPr>
            <a:cxnSpLocks/>
          </p:cNvCxnSpPr>
          <p:nvPr/>
        </p:nvCxnSpPr>
        <p:spPr>
          <a:xfrm>
            <a:off x="724535" y="992771"/>
            <a:ext cx="20822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07E2211-1F8B-4528-A871-4A889C76B09D}"/>
              </a:ext>
            </a:extLst>
          </p:cNvPr>
          <p:cNvSpPr txBox="1"/>
          <p:nvPr/>
        </p:nvSpPr>
        <p:spPr>
          <a:xfrm>
            <a:off x="308399" y="659478"/>
            <a:ext cx="89826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LM8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555CDD46-28DF-42D1-8D61-35B684DB8BF3}"/>
              </a:ext>
            </a:extLst>
          </p:cNvPr>
          <p:cNvSpPr/>
          <p:nvPr/>
        </p:nvSpPr>
        <p:spPr>
          <a:xfrm>
            <a:off x="3803479" y="690503"/>
            <a:ext cx="2592288" cy="561372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PAM (50 %)</a:t>
            </a: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CA1EA864-53EF-41CA-9CC8-814B9B73D051}"/>
              </a:ext>
            </a:extLst>
          </p:cNvPr>
          <p:cNvSpPr/>
          <p:nvPr/>
        </p:nvSpPr>
        <p:spPr>
          <a:xfrm>
            <a:off x="4028820" y="952193"/>
            <a:ext cx="2207244" cy="307043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4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  1       6      12      24     48 (h)</a:t>
            </a: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A936A6D0-238F-4C7A-A484-2EADFFEC9252}"/>
              </a:ext>
            </a:extLst>
          </p:cNvPr>
          <p:cNvCxnSpPr>
            <a:cxnSpLocks/>
          </p:cNvCxnSpPr>
          <p:nvPr/>
        </p:nvCxnSpPr>
        <p:spPr>
          <a:xfrm>
            <a:off x="4058478" y="992771"/>
            <a:ext cx="20822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89F8106-BB1D-43AD-8435-B93D85AE9C8F}"/>
              </a:ext>
            </a:extLst>
          </p:cNvPr>
          <p:cNvSpPr txBox="1"/>
          <p:nvPr/>
        </p:nvSpPr>
        <p:spPr>
          <a:xfrm>
            <a:off x="3642342" y="659478"/>
            <a:ext cx="89826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43B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1F7141E4-0486-40EE-9294-2D4A720F1C0C}"/>
              </a:ext>
            </a:extLst>
          </p:cNvPr>
          <p:cNvSpPr/>
          <p:nvPr/>
        </p:nvSpPr>
        <p:spPr>
          <a:xfrm>
            <a:off x="468944" y="3357539"/>
            <a:ext cx="2592288" cy="561372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PAM (50 %)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5A6C6164-21A8-4FEB-9995-EADCD5229D49}"/>
              </a:ext>
            </a:extLst>
          </p:cNvPr>
          <p:cNvSpPr/>
          <p:nvPr/>
        </p:nvSpPr>
        <p:spPr>
          <a:xfrm>
            <a:off x="694285" y="3619229"/>
            <a:ext cx="2207244" cy="307043"/>
          </a:xfrm>
          <a:prstGeom prst="rect">
            <a:avLst/>
          </a:prstGeom>
        </p:spPr>
        <p:txBody>
          <a:bodyPr wrap="square">
            <a:no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4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  1       6      12      24     48 (h)</a:t>
            </a: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F039A489-5028-4B2A-984B-A5F8F1BDFB21}"/>
              </a:ext>
            </a:extLst>
          </p:cNvPr>
          <p:cNvCxnSpPr>
            <a:cxnSpLocks/>
          </p:cNvCxnSpPr>
          <p:nvPr/>
        </p:nvCxnSpPr>
        <p:spPr>
          <a:xfrm>
            <a:off x="723943" y="3659807"/>
            <a:ext cx="20822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74E7C82-887C-43BC-90FD-CCB1A7383C40}"/>
              </a:ext>
            </a:extLst>
          </p:cNvPr>
          <p:cNvSpPr txBox="1"/>
          <p:nvPr/>
        </p:nvSpPr>
        <p:spPr>
          <a:xfrm>
            <a:off x="307807" y="3326514"/>
            <a:ext cx="898264" cy="2779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43B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3BE967C-FA34-420E-AA5F-BC6E1C2797BF}"/>
              </a:ext>
            </a:extLst>
          </p:cNvPr>
          <p:cNvSpPr txBox="1"/>
          <p:nvPr/>
        </p:nvSpPr>
        <p:spPr>
          <a:xfrm>
            <a:off x="2862295" y="2353946"/>
            <a:ext cx="8148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C3 A/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25C6B7D1-9F69-45F7-AA8A-414069F56418}"/>
              </a:ext>
            </a:extLst>
          </p:cNvPr>
          <p:cNvCxnSpPr>
            <a:cxnSpLocks/>
          </p:cNvCxnSpPr>
          <p:nvPr/>
        </p:nvCxnSpPr>
        <p:spPr>
          <a:xfrm flipH="1">
            <a:off x="2688250" y="2482346"/>
            <a:ext cx="216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6CF6CF-896D-4944-8AD4-723EEC8E7288}"/>
              </a:ext>
            </a:extLst>
          </p:cNvPr>
          <p:cNvSpPr txBox="1"/>
          <p:nvPr/>
        </p:nvSpPr>
        <p:spPr>
          <a:xfrm>
            <a:off x="288843" y="267342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0E974BE-AA02-4083-ADB6-3426F3384E2C}"/>
              </a:ext>
            </a:extLst>
          </p:cNvPr>
          <p:cNvSpPr txBox="1"/>
          <p:nvPr/>
        </p:nvSpPr>
        <p:spPr>
          <a:xfrm>
            <a:off x="6134247" y="2492445"/>
            <a:ext cx="8148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C3 A/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71A8BC2F-6BDE-4420-9E94-E432B87149B4}"/>
              </a:ext>
            </a:extLst>
          </p:cNvPr>
          <p:cNvCxnSpPr>
            <a:cxnSpLocks/>
          </p:cNvCxnSpPr>
          <p:nvPr/>
        </p:nvCxnSpPr>
        <p:spPr>
          <a:xfrm flipH="1">
            <a:off x="5967822" y="2620845"/>
            <a:ext cx="216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15F9181-1BAE-4EC6-9BDF-16CBDE2FF41D}"/>
              </a:ext>
            </a:extLst>
          </p:cNvPr>
          <p:cNvSpPr txBox="1"/>
          <p:nvPr/>
        </p:nvSpPr>
        <p:spPr>
          <a:xfrm>
            <a:off x="2886289" y="5022719"/>
            <a:ext cx="8148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C3 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FA4A7915-16CF-4690-BB88-82DAA9E9F394}"/>
              </a:ext>
            </a:extLst>
          </p:cNvPr>
          <p:cNvCxnSpPr>
            <a:cxnSpLocks/>
          </p:cNvCxnSpPr>
          <p:nvPr/>
        </p:nvCxnSpPr>
        <p:spPr>
          <a:xfrm flipH="1">
            <a:off x="2712244" y="5151119"/>
            <a:ext cx="216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DEDA396-1E4A-4D95-B251-2AF597D9EA96}"/>
              </a:ext>
            </a:extLst>
          </p:cNvPr>
          <p:cNvSpPr txBox="1"/>
          <p:nvPr/>
        </p:nvSpPr>
        <p:spPr>
          <a:xfrm>
            <a:off x="288843" y="233824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9A76214-86EE-4B36-A912-81666FBDB00F}"/>
              </a:ext>
            </a:extLst>
          </p:cNvPr>
          <p:cNvSpPr txBox="1"/>
          <p:nvPr/>
        </p:nvSpPr>
        <p:spPr>
          <a:xfrm>
            <a:off x="288843" y="198775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B11A09C-BBCF-4E1C-98C7-53D503DBA167}"/>
              </a:ext>
            </a:extLst>
          </p:cNvPr>
          <p:cNvSpPr txBox="1"/>
          <p:nvPr/>
        </p:nvSpPr>
        <p:spPr>
          <a:xfrm>
            <a:off x="288843" y="162346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A399730-8208-4095-A869-916DD5170791}"/>
              </a:ext>
            </a:extLst>
          </p:cNvPr>
          <p:cNvSpPr txBox="1"/>
          <p:nvPr/>
        </p:nvSpPr>
        <p:spPr>
          <a:xfrm>
            <a:off x="3649263" y="287154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2A7C64C-A42C-445C-B5AA-F7CBACF48851}"/>
              </a:ext>
            </a:extLst>
          </p:cNvPr>
          <p:cNvSpPr txBox="1"/>
          <p:nvPr/>
        </p:nvSpPr>
        <p:spPr>
          <a:xfrm>
            <a:off x="3649263" y="253636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3535794-B900-43E1-9E32-A8F00D973FC0}"/>
              </a:ext>
            </a:extLst>
          </p:cNvPr>
          <p:cNvSpPr txBox="1"/>
          <p:nvPr/>
        </p:nvSpPr>
        <p:spPr>
          <a:xfrm>
            <a:off x="3649263" y="218587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ECDD552-9B81-48BB-B1D7-180255313955}"/>
              </a:ext>
            </a:extLst>
          </p:cNvPr>
          <p:cNvSpPr txBox="1"/>
          <p:nvPr/>
        </p:nvSpPr>
        <p:spPr>
          <a:xfrm>
            <a:off x="3649263" y="182158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A120ADF-6296-485C-AF6E-4F6F8D30A512}"/>
              </a:ext>
            </a:extLst>
          </p:cNvPr>
          <p:cNvSpPr txBox="1"/>
          <p:nvPr/>
        </p:nvSpPr>
        <p:spPr>
          <a:xfrm>
            <a:off x="258363" y="540138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6C4FB43-F68B-4FA3-A847-A5F736F78F7E}"/>
              </a:ext>
            </a:extLst>
          </p:cNvPr>
          <p:cNvSpPr txBox="1"/>
          <p:nvPr/>
        </p:nvSpPr>
        <p:spPr>
          <a:xfrm>
            <a:off x="258363" y="5066205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2E44A28-A4F5-429C-AE1C-10A05A62FD1F}"/>
              </a:ext>
            </a:extLst>
          </p:cNvPr>
          <p:cNvSpPr txBox="1"/>
          <p:nvPr/>
        </p:nvSpPr>
        <p:spPr>
          <a:xfrm>
            <a:off x="258363" y="4715713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EDD0993-A110-4758-AAAA-990ED219DED5}"/>
              </a:ext>
            </a:extLst>
          </p:cNvPr>
          <p:cNvSpPr txBox="1"/>
          <p:nvPr/>
        </p:nvSpPr>
        <p:spPr>
          <a:xfrm>
            <a:off x="258363" y="4351424"/>
            <a:ext cx="354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ED23B5D-EDB4-483A-80C5-6EB89D1C94DA}"/>
              </a:ext>
            </a:extLst>
          </p:cNvPr>
          <p:cNvSpPr txBox="1"/>
          <p:nvPr/>
        </p:nvSpPr>
        <p:spPr>
          <a:xfrm>
            <a:off x="2560559" y="807307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1898CF00-6331-4EFE-A744-95EEA75C6A58}"/>
              </a:ext>
            </a:extLst>
          </p:cNvPr>
          <p:cNvSpPr txBox="1"/>
          <p:nvPr/>
        </p:nvSpPr>
        <p:spPr>
          <a:xfrm>
            <a:off x="987948" y="6213768"/>
            <a:ext cx="9092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C3 B (LM8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D3B1B86C-3ADF-4E38-A737-DEE98FD5C923}"/>
              </a:ext>
            </a:extLst>
          </p:cNvPr>
          <p:cNvGraphicFramePr>
            <a:graphicFrameLocks/>
          </p:cNvGraphicFramePr>
          <p:nvPr/>
        </p:nvGraphicFramePr>
        <p:xfrm>
          <a:off x="677206" y="6336879"/>
          <a:ext cx="216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17247E81-7DAB-4C57-A3B6-D807A690F248}"/>
              </a:ext>
            </a:extLst>
          </p:cNvPr>
          <p:cNvSpPr txBox="1"/>
          <p:nvPr/>
        </p:nvSpPr>
        <p:spPr>
          <a:xfrm rot="16200000">
            <a:off x="-311436" y="7118677"/>
            <a:ext cx="18245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(% area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B4FB8CC1-F27F-451D-A91D-10B955B3C843}"/>
              </a:ext>
            </a:extLst>
          </p:cNvPr>
          <p:cNvGraphicFramePr>
            <a:graphicFrameLocks/>
          </p:cNvGraphicFramePr>
          <p:nvPr/>
        </p:nvGraphicFramePr>
        <p:xfrm>
          <a:off x="3218343" y="6336879"/>
          <a:ext cx="216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A9765B4-9008-4325-AA41-27D734E35BB1}"/>
              </a:ext>
            </a:extLst>
          </p:cNvPr>
          <p:cNvSpPr txBox="1"/>
          <p:nvPr/>
        </p:nvSpPr>
        <p:spPr>
          <a:xfrm rot="16200000">
            <a:off x="2272428" y="7118677"/>
            <a:ext cx="18245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(% area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F8CF713-424A-4AAA-A6DB-3009540425C3}"/>
              </a:ext>
            </a:extLst>
          </p:cNvPr>
          <p:cNvSpPr txBox="1"/>
          <p:nvPr/>
        </p:nvSpPr>
        <p:spPr>
          <a:xfrm>
            <a:off x="5098019" y="8073075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62DBFD3-AA23-4CEB-99B2-81CB4260082A}"/>
              </a:ext>
            </a:extLst>
          </p:cNvPr>
          <p:cNvSpPr txBox="1"/>
          <p:nvPr/>
        </p:nvSpPr>
        <p:spPr>
          <a:xfrm>
            <a:off x="3479688" y="6213768"/>
            <a:ext cx="9573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C3 B (143B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76150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45DDB40-7942-45E8-BBFF-B892AB6F3402}"/>
              </a:ext>
            </a:extLst>
          </p:cNvPr>
          <p:cNvSpPr txBox="1"/>
          <p:nvPr/>
        </p:nvSpPr>
        <p:spPr>
          <a:xfrm>
            <a:off x="5070088" y="113309"/>
            <a:ext cx="18714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</a:p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DE862A4-938C-4FF9-B737-0DEB48D5BE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3920" y="1871663"/>
            <a:ext cx="1440000" cy="10800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B562BC9-8C83-454F-AA5F-F788461620B4}"/>
              </a:ext>
            </a:extLst>
          </p:cNvPr>
          <p:cNvSpPr txBox="1"/>
          <p:nvPr/>
        </p:nvSpPr>
        <p:spPr>
          <a:xfrm>
            <a:off x="1379351" y="1625442"/>
            <a:ext cx="571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B9557AE-7DEB-4F02-BC40-071DEA01BB02}"/>
              </a:ext>
            </a:extLst>
          </p:cNvPr>
          <p:cNvSpPr txBox="1"/>
          <p:nvPr/>
        </p:nvSpPr>
        <p:spPr>
          <a:xfrm>
            <a:off x="2925379" y="1488944"/>
            <a:ext cx="7251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PAM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93FEE8B-8256-4726-85E3-DAA97FE6B2A6}"/>
              </a:ext>
            </a:extLst>
          </p:cNvPr>
          <p:cNvSpPr txBox="1"/>
          <p:nvPr/>
        </p:nvSpPr>
        <p:spPr>
          <a:xfrm>
            <a:off x="4629058" y="1488944"/>
            <a:ext cx="5715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PAM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FCDC4BB-4034-405C-A262-F0B618FD4D25}"/>
              </a:ext>
            </a:extLst>
          </p:cNvPr>
          <p:cNvSpPr txBox="1"/>
          <p:nvPr/>
        </p:nvSpPr>
        <p:spPr>
          <a:xfrm>
            <a:off x="364910" y="2288552"/>
            <a:ext cx="571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O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FCB8FBAD-1450-47C1-9115-E8B2E0D564C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976" y="1871662"/>
            <a:ext cx="1440000" cy="1080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60360B78-E76D-4A76-B36D-1F3911ABE8F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2032" y="1871662"/>
            <a:ext cx="1440000" cy="10800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A79DB60A-85DB-444C-8770-C82C3705E12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3920" y="3557919"/>
            <a:ext cx="1440000" cy="1080000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C6FE76E-280F-4196-B8EF-1B12E39E9C50}"/>
              </a:ext>
            </a:extLst>
          </p:cNvPr>
          <p:cNvSpPr txBox="1"/>
          <p:nvPr/>
        </p:nvSpPr>
        <p:spPr>
          <a:xfrm>
            <a:off x="364910" y="3974808"/>
            <a:ext cx="571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43B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8DB8657-FAA8-4014-A5B3-EB096E3F4933}"/>
              </a:ext>
            </a:extLst>
          </p:cNvPr>
          <p:cNvSpPr txBox="1"/>
          <p:nvPr/>
        </p:nvSpPr>
        <p:spPr>
          <a:xfrm>
            <a:off x="1379351" y="3334380"/>
            <a:ext cx="571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7ABED29-B09D-4BE6-9BED-51ED630BEB0A}"/>
              </a:ext>
            </a:extLst>
          </p:cNvPr>
          <p:cNvSpPr txBox="1"/>
          <p:nvPr/>
        </p:nvSpPr>
        <p:spPr>
          <a:xfrm>
            <a:off x="2925379" y="3197882"/>
            <a:ext cx="7251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PAM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72264B6-5335-465C-A1E9-EB346D1EDC60}"/>
              </a:ext>
            </a:extLst>
          </p:cNvPr>
          <p:cNvSpPr txBox="1"/>
          <p:nvPr/>
        </p:nvSpPr>
        <p:spPr>
          <a:xfrm>
            <a:off x="4629058" y="3197882"/>
            <a:ext cx="5715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PAM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D565BC63-6A21-483D-8666-358F75AF8A1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976" y="3557918"/>
            <a:ext cx="1440000" cy="1080000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6B7457C0-DE99-44DB-80DF-A730106F6FF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2032" y="3555808"/>
            <a:ext cx="1440000" cy="1080000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9C563AD-042A-4C1D-A865-D3F36381F4B9}"/>
              </a:ext>
            </a:extLst>
          </p:cNvPr>
          <p:cNvSpPr txBox="1"/>
          <p:nvPr/>
        </p:nvSpPr>
        <p:spPr>
          <a:xfrm>
            <a:off x="364910" y="5661064"/>
            <a:ext cx="571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I-38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801119E-925A-47B3-90C5-01DCBC24D4B4}"/>
              </a:ext>
            </a:extLst>
          </p:cNvPr>
          <p:cNvSpPr txBox="1"/>
          <p:nvPr/>
        </p:nvSpPr>
        <p:spPr>
          <a:xfrm>
            <a:off x="1379351" y="5020636"/>
            <a:ext cx="571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8A1C525-EA9D-4F8C-8F7C-CEF4892D6AA8}"/>
              </a:ext>
            </a:extLst>
          </p:cNvPr>
          <p:cNvSpPr txBox="1"/>
          <p:nvPr/>
        </p:nvSpPr>
        <p:spPr>
          <a:xfrm>
            <a:off x="2925379" y="4884138"/>
            <a:ext cx="7251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PAM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10C2E9F-474B-44A3-B41F-207D66EBB690}"/>
              </a:ext>
            </a:extLst>
          </p:cNvPr>
          <p:cNvSpPr txBox="1"/>
          <p:nvPr/>
        </p:nvSpPr>
        <p:spPr>
          <a:xfrm>
            <a:off x="4629058" y="4884138"/>
            <a:ext cx="5715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PAM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%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図 32">
            <a:extLst>
              <a:ext uri="{FF2B5EF4-FFF2-40B4-BE49-F238E27FC236}">
                <a16:creationId xmlns:a16="http://schemas.microsoft.com/office/drawing/2014/main" id="{DA941D29-30BB-4B49-92DA-7F286E46B02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3920" y="5244174"/>
            <a:ext cx="1440000" cy="1080000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D590FAB3-5A05-4655-882B-54ABEE10EB8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2032" y="5260253"/>
            <a:ext cx="1440000" cy="1080000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1A226EAD-AAED-40A3-A851-4965F9C75D5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976" y="5266857"/>
            <a:ext cx="1440000" cy="1080000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BBEB868-FB9E-49D1-B8C0-024B91D4F1B0}"/>
              </a:ext>
            </a:extLst>
          </p:cNvPr>
          <p:cNvSpPr txBox="1"/>
          <p:nvPr/>
        </p:nvSpPr>
        <p:spPr>
          <a:xfrm>
            <a:off x="572322" y="1607703"/>
            <a:ext cx="3791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F5B2412-4388-436B-A638-54FEA01FB018}"/>
              </a:ext>
            </a:extLst>
          </p:cNvPr>
          <p:cNvSpPr txBox="1"/>
          <p:nvPr/>
        </p:nvSpPr>
        <p:spPr>
          <a:xfrm>
            <a:off x="572322" y="3288213"/>
            <a:ext cx="3791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ADE9DBF-9A8D-4C25-96A1-C97D654CF2BF}"/>
              </a:ext>
            </a:extLst>
          </p:cNvPr>
          <p:cNvSpPr txBox="1"/>
          <p:nvPr/>
        </p:nvSpPr>
        <p:spPr>
          <a:xfrm>
            <a:off x="572321" y="4967191"/>
            <a:ext cx="3791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43793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CDB3332-FA1B-4F53-B283-E29E18DB1424}"/>
              </a:ext>
            </a:extLst>
          </p:cNvPr>
          <p:cNvSpPr txBox="1"/>
          <p:nvPr/>
        </p:nvSpPr>
        <p:spPr>
          <a:xfrm>
            <a:off x="685800" y="1736028"/>
            <a:ext cx="4697730" cy="55083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25500" algn="l">
              <a:lnSpc>
                <a:spcPts val="1300"/>
              </a:lnSpc>
            </a:pPr>
            <a:r>
              <a:rPr lang="en-US" altLang="ja-JP" sz="1000" b="1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Legends</a:t>
            </a:r>
            <a:endParaRPr lang="ja-JP" altLang="ja-JP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825500" algn="just">
              <a:lnSpc>
                <a:spcPts val="1300"/>
              </a:lnSpc>
              <a:spcBef>
                <a:spcPts val="1200"/>
              </a:spcBef>
              <a:spcAft>
                <a:spcPts val="600"/>
              </a:spcAft>
              <a:tabLst>
                <a:tab pos="2628900" algn="l"/>
              </a:tabLst>
            </a:pPr>
            <a:r>
              <a:rPr lang="en-US" altLang="ja-JP" sz="1000" b="1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S1. Schematic diagram showing the experimental design for </a:t>
            </a:r>
            <a:r>
              <a:rPr lang="en-US" altLang="ja-JP" sz="1000" b="1" i="1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in vivo </a:t>
            </a:r>
            <a:r>
              <a:rPr lang="en-US" altLang="ja-JP" sz="1000" b="1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ntitumor activity assay.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ells (1 × 10</a:t>
            </a:r>
            <a:r>
              <a:rPr lang="en-US" altLang="ja-JP" sz="1000" baseline="30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cells/mouse) in 0.1 ml DMEM were inoculated on day 0. From day 7, APAM (50%) was administered three times per week intravenously to 6 mice per group. The mice were weighed, and the size of the primary tumors was measured every week. On day 35, all mice were sacrificed. </a:t>
            </a:r>
            <a:endParaRPr lang="ja-JP" altLang="ja-JP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825500" algn="just">
              <a:lnSpc>
                <a:spcPts val="1300"/>
              </a:lnSpc>
              <a:spcBef>
                <a:spcPts val="1200"/>
              </a:spcBef>
              <a:spcAft>
                <a:spcPts val="600"/>
              </a:spcAft>
              <a:tabLst>
                <a:tab pos="2628900" algn="l"/>
              </a:tabLst>
            </a:pPr>
            <a:r>
              <a:rPr lang="en-US" altLang="ja-JP" sz="1000" b="1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S2.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, B.</a:t>
            </a:r>
            <a:r>
              <a:rPr lang="en-US" altLang="ja-JP" sz="1000" b="1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xamples of uncropped western blots (A) and quantification (B) for cleaved caspase-3 and GAPDH in Fig. 2C, D. </a:t>
            </a:r>
            <a:endParaRPr lang="ja-JP" altLang="ja-JP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825500" algn="just">
              <a:lnSpc>
                <a:spcPts val="1300"/>
              </a:lnSpc>
              <a:spcBef>
                <a:spcPts val="1200"/>
              </a:spcBef>
              <a:spcAft>
                <a:spcPts val="600"/>
              </a:spcAft>
              <a:tabLst>
                <a:tab pos="2628900" algn="l"/>
              </a:tabLst>
            </a:pPr>
            <a:r>
              <a:rPr lang="en-US" altLang="ja-JP" sz="1000" b="1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S3.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, B.</a:t>
            </a:r>
            <a:r>
              <a:rPr lang="en-US" altLang="ja-JP" sz="1000" b="1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Examples of uncropped western blots (A) and quantification (B) for LC3-A/B, LC-3B, and GAPDH in Fig. 3C. </a:t>
            </a:r>
            <a:endParaRPr lang="ja-JP" altLang="ja-JP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825500" algn="just">
              <a:lnSpc>
                <a:spcPts val="1300"/>
              </a:lnSpc>
              <a:spcBef>
                <a:spcPts val="1200"/>
              </a:spcBef>
              <a:spcAft>
                <a:spcPts val="600"/>
              </a:spcAft>
              <a:tabLst>
                <a:tab pos="2628900" algn="l"/>
              </a:tabLst>
            </a:pPr>
            <a:r>
              <a:rPr lang="en-US" altLang="ja-JP" sz="1000" b="1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S4. Examples of the measurements of the occupied mitochondrial area (OMA).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HOS (A), 143B (B), and WI-38 cells (C) were treated with APAM (25, 50%) for 18 h, and m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itochondria and the nuclei were stained with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MitoTracker Red CMXRos (red) and Hoechst 33342 (blue)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, respectively.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Images were obtained using a BZ710 Digital Biological Microscope equipped with a 100 × coverslip-corrected oil objective and analyzed using the BZ-H3A application. OMA was manually selected in three pictures indicated by the yellow line and automatically measured using the BZ-H3M application. Bar = 10 μm.</a:t>
            </a:r>
            <a:endParaRPr lang="ja-JP" altLang="ja-JP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ts val="1300"/>
              </a:lnSpc>
            </a:pPr>
            <a:b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</a:rPr>
            </a:br>
            <a:r>
              <a:rPr lang="en-US" altLang="ja-JP" sz="1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endParaRPr lang="ja-JP" altLang="ja-JP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6766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</TotalTime>
  <Words>578</Words>
  <Application>Microsoft Office PowerPoint</Application>
  <PresentationFormat>画面に合わせる (4:3)</PresentationFormat>
  <Paragraphs>134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Segoe UI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 良弘</dc:creator>
  <cp:lastModifiedBy>鈴木 良弘</cp:lastModifiedBy>
  <cp:revision>4</cp:revision>
  <dcterms:created xsi:type="dcterms:W3CDTF">2021-10-31T07:38:37Z</dcterms:created>
  <dcterms:modified xsi:type="dcterms:W3CDTF">2021-11-24T00:58:09Z</dcterms:modified>
</cp:coreProperties>
</file>